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FE272-8D56-4AA3-8BA1-1088E64D3B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03C59-78E6-4C8E-92B8-CED14B17A1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4FDE3-E61A-4348-BBA1-7178F0795C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6D971-6365-4522-A7CA-1D0A1379B9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16E69-E802-4CD2-A6D4-1612F86449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9D1A9-7F6A-4D55-91E4-3EC7CBB973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70D0F-09A9-4125-A0D7-FA7EA38550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22D15-3D0C-4018-959C-D4277576E8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A0706-D53A-44E3-B220-EF15149F94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9325F-F6A0-4CD1-9826-A763AA30B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C5BFB-05E2-4B00-9B8E-F68A1FDBE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2D864-6D77-414A-8C4E-7610794E7B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7BA3A9-ACA6-4082-A6C0-CD910DB50C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42920" y="404640"/>
            <a:ext cx="6840720" cy="5402520"/>
            <a:chOff x="1042920" y="404640"/>
            <a:chExt cx="6840720" cy="54025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116000" y="1341360"/>
              <a:ext cx="6767640" cy="446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042920" y="404640"/>
              <a:ext cx="669780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Times New Roman"/>
                </a:rPr>
                <a:t>Figure S1: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Representative echocardiographic images of a bicuspid aortic valve  (A); a tricuspid aortic valve (C); a dilated tubular aorta (B); and a normal aorta (D). A and C: short paraesternal views; B and D: long paraesternal views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                         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05T10:17:23Z</dcterms:created>
  <dc:creator>laboratorio</dc:creator>
  <dc:description/>
  <dc:language>en-US</dc:language>
  <cp:lastModifiedBy>laboratorio</cp:lastModifiedBy>
  <dcterms:modified xsi:type="dcterms:W3CDTF">2013-12-09T11:48:00Z</dcterms:modified>
  <cp:revision>4</cp:revision>
  <dc:subject/>
  <dc:title>Diapositiva 1</dc:title>
</cp:coreProperties>
</file>